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878B1-CB75-44A7-872E-9184575437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58019-F972-48E7-81AC-971F40FC6F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1E667C-020F-4E22-8D8A-14D661FFAF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680F4-1E45-4F95-A82F-CCD1E026F2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29738-8192-4C12-AE68-1EB99535D3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E06FB-23EA-4081-AB05-71C0633C3B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EC5B0-0B39-499F-9C13-C50D903A20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21FC6-F5C7-4DF8-93FD-07026197F5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6EFCE-DBBE-4D74-82DD-19C211C292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48428-0392-450E-BFFB-B67D8EC5D0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777E9-5FCE-40C4-A66A-8D0385C5A5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21DD8-1AD9-44B7-BEEB-8957236DF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C58052-B96B-4336-B4F5-6E9118E8EF47}" type="datetime">
              <a:rPr b="0" lang="en-US" sz="1200" spc="-1" strike="noStrike">
                <a:solidFill>
                  <a:srgbClr val="898989"/>
                </a:solidFill>
                <a:latin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65DE39-E38C-497C-8567-ABFD43F7F6A9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581120" y="579600"/>
            <a:ext cx="22096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Transfe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of  CHO K1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1581120" y="1357200"/>
            <a:ext cx="20764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Antibiotic sele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/ml G41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1595520" y="2209680"/>
            <a:ext cx="218124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Primary Screen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V capture ELIS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4354560" y="2428920"/>
            <a:ext cx="205740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cale up selected clones to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 well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(500-600 clon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Down Arrow 8"/>
          <p:cNvSpPr/>
          <p:nvPr/>
        </p:nvSpPr>
        <p:spPr>
          <a:xfrm>
            <a:off x="2660760" y="1050840"/>
            <a:ext cx="90360" cy="216000"/>
          </a:xfrm>
          <a:prstGeom prst="downArrow">
            <a:avLst>
              <a:gd name="adj1" fmla="val 50000"/>
              <a:gd name="adj2" fmla="val 50088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Down Arrow 9"/>
          <p:cNvSpPr/>
          <p:nvPr/>
        </p:nvSpPr>
        <p:spPr>
          <a:xfrm>
            <a:off x="2660760" y="2776680"/>
            <a:ext cx="90360" cy="215640"/>
          </a:xfrm>
          <a:prstGeom prst="downArrow">
            <a:avLst>
              <a:gd name="adj1" fmla="val 50000"/>
              <a:gd name="adj2" fmla="val 50005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Down Arrow 10"/>
          <p:cNvSpPr/>
          <p:nvPr/>
        </p:nvSpPr>
        <p:spPr>
          <a:xfrm>
            <a:off x="2660760" y="1954080"/>
            <a:ext cx="90360" cy="216000"/>
          </a:xfrm>
          <a:prstGeom prst="downArrow">
            <a:avLst>
              <a:gd name="adj1" fmla="val 50000"/>
              <a:gd name="adj2" fmla="val 50088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3"/>
          <p:cNvSpPr/>
          <p:nvPr/>
        </p:nvSpPr>
        <p:spPr>
          <a:xfrm>
            <a:off x="4525920" y="1646280"/>
            <a:ext cx="171468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ansfer clones to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96 well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(1500-2000 clon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5"/>
          <p:cNvSpPr/>
          <p:nvPr/>
        </p:nvSpPr>
        <p:spPr>
          <a:xfrm>
            <a:off x="1468440" y="3063960"/>
            <a:ext cx="24354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Secondary Screen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V capture ELIS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0" name="Straight Arrow Connector 20"/>
          <p:cNvCxnSpPr/>
          <p:nvPr/>
        </p:nvCxnSpPr>
        <p:spPr>
          <a:xfrm>
            <a:off x="3962160" y="1821960"/>
            <a:ext cx="2163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1" name="Rectangle 21"/>
          <p:cNvSpPr/>
          <p:nvPr/>
        </p:nvSpPr>
        <p:spPr>
          <a:xfrm>
            <a:off x="1468440" y="3916440"/>
            <a:ext cx="24354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Continued Screen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V capture ELIS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2"/>
          <p:cNvSpPr/>
          <p:nvPr/>
        </p:nvSpPr>
        <p:spPr>
          <a:xfrm>
            <a:off x="4191120" y="3191040"/>
            <a:ext cx="238284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cale up select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lones to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 well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(100-150 clon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3"/>
          <p:cNvSpPr/>
          <p:nvPr/>
        </p:nvSpPr>
        <p:spPr>
          <a:xfrm>
            <a:off x="609480" y="4770360"/>
            <a:ext cx="4152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Continued Screen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V capture ELISA 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Western 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4"/>
          <p:cNvSpPr/>
          <p:nvPr/>
        </p:nvSpPr>
        <p:spPr>
          <a:xfrm>
            <a:off x="4562640" y="4846680"/>
            <a:ext cx="164124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lection of top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25 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" name="Straight Arrow Connector 25"/>
          <p:cNvCxnSpPr/>
          <p:nvPr/>
        </p:nvCxnSpPr>
        <p:spPr>
          <a:xfrm>
            <a:off x="3962160" y="3322440"/>
            <a:ext cx="2163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Straight Arrow Connector 26"/>
          <p:cNvCxnSpPr/>
          <p:nvPr/>
        </p:nvCxnSpPr>
        <p:spPr>
          <a:xfrm>
            <a:off x="3962160" y="2523600"/>
            <a:ext cx="2163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Straight Arrow Connector 27"/>
          <p:cNvCxnSpPr/>
          <p:nvPr/>
        </p:nvCxnSpPr>
        <p:spPr>
          <a:xfrm>
            <a:off x="3962160" y="5033520"/>
            <a:ext cx="2163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8" name="Down Arrow 28"/>
          <p:cNvSpPr/>
          <p:nvPr/>
        </p:nvSpPr>
        <p:spPr>
          <a:xfrm>
            <a:off x="2660760" y="3619440"/>
            <a:ext cx="90360" cy="216000"/>
          </a:xfrm>
          <a:prstGeom prst="downArrow">
            <a:avLst>
              <a:gd name="adj1" fmla="val 50000"/>
              <a:gd name="adj2" fmla="val 50088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Down Arrow 29"/>
          <p:cNvSpPr/>
          <p:nvPr/>
        </p:nvSpPr>
        <p:spPr>
          <a:xfrm>
            <a:off x="2660760" y="4464000"/>
            <a:ext cx="90360" cy="216000"/>
          </a:xfrm>
          <a:prstGeom prst="downArrow">
            <a:avLst>
              <a:gd name="adj1" fmla="val 50000"/>
              <a:gd name="adj2" fmla="val 50088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54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4"/>
          <p:cNvSpPr/>
          <p:nvPr/>
        </p:nvSpPr>
        <p:spPr>
          <a:xfrm>
            <a:off x="992160" y="5715000"/>
            <a:ext cx="15224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Stability Study (+/- G418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Down Arrow 41"/>
          <p:cNvSpPr/>
          <p:nvPr/>
        </p:nvSpPr>
        <p:spPr>
          <a:xfrm rot="18900000">
            <a:off x="3030120" y="5320800"/>
            <a:ext cx="88920" cy="216000"/>
          </a:xfrm>
          <a:prstGeom prst="downArrow">
            <a:avLst>
              <a:gd name="adj1" fmla="val 50000"/>
              <a:gd name="adj2" fmla="val 50011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81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2"/>
          <p:cNvSpPr/>
          <p:nvPr/>
        </p:nvSpPr>
        <p:spPr>
          <a:xfrm>
            <a:off x="2819520" y="5638680"/>
            <a:ext cx="27432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Adaptation to suspension culture and ACF mediu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4"/>
          <p:cNvSpPr/>
          <p:nvPr/>
        </p:nvSpPr>
        <p:spPr>
          <a:xfrm>
            <a:off x="6172200" y="5608800"/>
            <a:ext cx="22096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12 clones </a:t>
            </a: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to 0.5 l fed-batch bioreactor 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(Supplementary Figure S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Down Arrow 49"/>
          <p:cNvSpPr/>
          <p:nvPr/>
        </p:nvSpPr>
        <p:spPr>
          <a:xfrm rot="2700000">
            <a:off x="2349360" y="5303520"/>
            <a:ext cx="88920" cy="216000"/>
          </a:xfrm>
          <a:prstGeom prst="downArrow">
            <a:avLst>
              <a:gd name="adj1" fmla="val 50000"/>
              <a:gd name="adj2" fmla="val 50011"/>
            </a:avLst>
          </a:prstGeom>
          <a:gradFill rotWithShape="0">
            <a:gsLst>
              <a:gs pos="0">
                <a:srgbClr val="ededed"/>
              </a:gs>
              <a:gs pos="100000">
                <a:srgbClr val="bcbcbc"/>
              </a:gs>
            </a:gsLst>
            <a:lin ang="27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3"/>
          <p:cNvSpPr/>
          <p:nvPr/>
        </p:nvSpPr>
        <p:spPr>
          <a:xfrm>
            <a:off x="5623200" y="6351480"/>
            <a:ext cx="334908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Straight Arrow Connector 30"/>
          <p:cNvCxnSpPr/>
          <p:nvPr/>
        </p:nvCxnSpPr>
        <p:spPr>
          <a:xfrm>
            <a:off x="5575320" y="5837040"/>
            <a:ext cx="2167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2T14:58:51Z</dcterms:created>
  <dc:creator>deyan3</dc:creator>
  <dc:description/>
  <dc:language>en-US</dc:language>
  <cp:lastModifiedBy>Carlo</cp:lastModifiedBy>
  <cp:lastPrinted>2015-01-02T11:46:15Z</cp:lastPrinted>
  <dcterms:modified xsi:type="dcterms:W3CDTF">2016-04-18T22:07:55Z</dcterms:modified>
  <cp:revision>184</cp:revision>
  <dc:subject/>
  <dc:title>Slide 1</dc:title>
</cp:coreProperties>
</file>